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88822DBF-C727-46D7-858A-0FB74E1CEFA0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6F1C833E-72C9-4597-8F9D-2FBCE092BBF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2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7842CF-A721-4D83-BFA5-50F7FC5AE3D6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97E0DB-3CCA-4C16-AE8C-D7F98260D05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529852-621F-4725-961C-3FC7B4B1E56E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602D22-151D-4B90-A8E4-E5C308FD362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D50D84-AD34-41A3-9F62-4970C710642C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05C651-D1DF-4B16-B7CA-F39C4EECC2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CBD67C-6836-420B-A2E7-17C89DF9714E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1969E9-DF60-41F8-9F41-DE3096A5CAD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48597E-5F2A-4A28-91E1-728C9DD90CAA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93A4EC-A71F-4A17-8026-2DA5BF538ED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48E998-A6BF-4110-BE22-CFD20D4A3365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D8FDFD-86F9-4EF8-8150-4FE9D423B99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E7534C-546E-4D80-805E-EDEE10791B41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694A67-1AF0-4C90-A011-438D2651C4E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4AA4A3-302A-4D33-B37E-CCE3188B0357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A6173F-D771-4EB7-B18B-89A70A8BA2E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801C4C-41B3-4AE9-AD64-34CDD73E386E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B8CB6B-43D5-43F1-91AA-ABCDDA9A822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96FB31-CCB3-450E-B3B0-61D7E2392868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C9D9B7-3D08-4FB7-9DD2-125E032F281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3EAAC1-C1FF-4444-A915-7B64C5FFBFCC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74BB6A-5BAA-4F56-A767-6E7A7DDD214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4B717CE-2A0E-4F86-81B6-2BC4F86CBD48}" type="datetimeFigureOut">
              <a:rPr lang="en-US"/>
              <a:pPr>
                <a:defRPr/>
              </a:pPr>
              <a:t>3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66B70FD-FE99-4A5E-B819-DFC99DEF11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228600" y="533400"/>
          <a:ext cx="8686800" cy="4953000"/>
        </p:xfrm>
        <a:graphic>
          <a:graphicData uri="http://schemas.openxmlformats.org/drawingml/2006/table">
            <a:tbl>
              <a:tblPr/>
              <a:tblGrid>
                <a:gridCol w="638175"/>
                <a:gridCol w="776288"/>
                <a:gridCol w="601662"/>
                <a:gridCol w="890588"/>
                <a:gridCol w="977900"/>
                <a:gridCol w="4802187"/>
              </a:tblGrid>
              <a:tr h="39846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nimal No.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ge (weeks)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athology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Remarks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VP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DLP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488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9.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2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Hyperplasia (AP), hyperplasia (VP), desmoplastic stroma (DLP)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492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9.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2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2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2 foci of PIN1 (AP), hyperplasia (VP), Single atypical cells (DLP)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17513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49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9.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Hyperplasia, cells with enlarged cytoplasm (AP), 2 small foci of </a:t>
                      </a:r>
                      <a:r>
                        <a:rPr kumimoji="0" lang="en-US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hyperplastic</a:t>
                      </a: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 cells (VP), moderate hyperplasia (DLP)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00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9.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1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ronounced exfoliation (DLP)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147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19.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148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19.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152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19.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0663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5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22.1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55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22.1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72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39.6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1611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61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40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 cells in lymphatic vessels (DLP)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615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40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616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40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76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4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41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3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54.1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0825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36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54.1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1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3 in proximal part, exfoliation (AP), focal hyperplasia (VP)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50825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586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54.6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9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356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56.6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222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5279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+mn-ea"/>
                          <a:cs typeface="Times New Roman" pitchFamily="18" charset="0"/>
                        </a:rPr>
                        <a:t>59.3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Early 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PIN4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AdCa</a:t>
                      </a:r>
                      <a:endParaRPr kumimoji="0" lang="en-US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Times New Roman" pitchFamily="18" charset="0"/>
                        </a:rPr>
                        <a:t> 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</a:txBody>
                  <a:tcPr marL="47512" marR="47512" marT="0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98</Words>
  <Application>Microsoft Office PowerPoint</Application>
  <PresentationFormat>On-screen Show (4:3)</PresentationFormat>
  <Paragraphs>12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elty</dc:creator>
  <cp:lastModifiedBy>Helty</cp:lastModifiedBy>
  <cp:revision>4</cp:revision>
  <dcterms:created xsi:type="dcterms:W3CDTF">2012-12-17T07:50:49Z</dcterms:created>
  <dcterms:modified xsi:type="dcterms:W3CDTF">2013-03-15T13:32:52Z</dcterms:modified>
</cp:coreProperties>
</file>